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3"/>
  </p:normalViewPr>
  <p:slideViewPr>
    <p:cSldViewPr snapToGrid="0" snapToObjects="1">
      <p:cViewPr varScale="1">
        <p:scale>
          <a:sx n="118" d="100"/>
          <a:sy n="118" d="100"/>
        </p:scale>
        <p:origin x="5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FE135-FD7A-B346-A706-5151611C52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11C81F-7810-E943-8C98-8072C85F5A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5B88DC-F346-6E46-B83D-FEB590BC8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65AD7A-9B69-B143-B375-0C75109B0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3D1DEA-2A2E-4F40-A1A2-D7F4AE80A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760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2DEEE-BCA6-9848-B2F3-031052F696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DCBE93-48E6-9846-B650-88BAB07E12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B84BD5-B88D-1A4B-A833-C37993BA54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8FE4C5-4830-9443-AE87-28B46CB72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B9D76C-95B0-AC46-A59A-B91E8E9A7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884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E7596D2-4CF1-4649-9ECD-F0165FD8FC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A7182E-AB99-264E-8568-9F4AC7B151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D9D4E3-6C58-0543-97D2-83D6EDA07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3E6DCE-4609-2F4E-87E5-13F901435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6CC0BC-E857-4E45-8108-083DAD74C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53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DB6035-05E3-444E-AEDF-3A3D467C0E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D05694-62D1-DE43-A689-21AE15A342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7F4CFB-CC40-9D43-8F6A-A6ED7BB24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0568BE-1A34-E946-96E5-FEBBDC78E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5C5D33-072E-EA4C-8B6D-50BB7EBE5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703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6EFBCA-2FC9-214A-AF3C-A39F22D5FA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78AACF-0C20-7E44-A7BC-DDBD1BDE13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2F6ABC-4AE9-3A4B-9EC8-0D5B06777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91129D-01BF-4249-9387-A7A4A6B147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27E521-E209-DF4B-AABF-555A59EB9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479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4ED17-2904-E04F-94A0-B30450CAB5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ACD682-769F-CE4D-ABF7-D95402A46E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3E75A0-30FA-B842-858A-D4658CCDA0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65EC1C-28B1-074D-BFBC-12D1C53F2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DF5A03-F7B8-C345-ACC6-2CC73E5D1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5D02E5-547D-C946-B44B-039FE0CFD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751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BA534-783C-0845-A7E7-F9F3CC0DD8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B4C32A-36E1-9E4E-A26B-B40BAFB240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8F0299-E283-A944-B609-2B4DF523CF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8EC2ED-CFC2-6B4C-AD72-6AF7BCEA0A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483B07-AF7E-2D4A-BA27-2A5CCFC15B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D11042-D71B-8A42-B883-C0A885923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9BCE28-AE66-D640-A46A-4E1353875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DC18491-EC34-2F46-8D2F-4363AB3FC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373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0EDBA4-C806-1043-B744-C87CEEFA1C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FBD8EB4-4484-6340-9131-FE329E23F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80215D-7042-CF42-9313-A24723EE3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EFD3F7-3254-784B-85E5-74C6C21F1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399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668543-5560-AE46-81AB-B3682A80E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CDD447-7D98-734E-AE0B-69341E219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D2E44F-D2BC-3646-9D05-58A0401A38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953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6F84C6-2D0C-C847-A235-8EEFC2474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2FFA93-B226-BF47-A3D6-657AA76EB0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5885D3-A8A3-5A47-B18E-AFB53DD98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356CD2-E46F-9042-837D-B940B6147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E2AFDF-732E-2248-8C43-BA646A77D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877296-EE39-F646-9B4D-071197404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679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81E828-C4FB-B644-A5A2-1C94CB3ED3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66A7EC-5939-AA45-82E8-24236B0C9A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2BF07D-75CA-C74E-B97E-8D8F5A5575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175CE6-FA14-244F-AF98-1B0270EB4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B0FADB-3535-024D-A9C4-CE99CADAA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90EE7C-BE15-CE48-B1EA-B58D2C152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747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1A7B1F6-FF24-FB40-9C67-C8690ADB1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CAA382-CC82-FC43-BA18-9BBE779E78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9DAD9-6722-5443-8736-603F8E1D69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CE9CE2-BA24-244B-A514-A7D6B5DB33CC}" type="datetimeFigureOut">
              <a:rPr lang="en-US" smtClean="0"/>
              <a:t>5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DA01A3-7DA6-8A43-9CE1-97277B6DE1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28DE86-C3D1-4F4A-A4B0-733872D23C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44C77-A37F-F348-A18A-31FA32472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141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1E3257-2A67-2C47-928D-742CFFBB64D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Virtual Realit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0EDAF0-7E63-384A-B724-F826DEB5522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958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19E022-7860-584C-8FED-B653FEFE40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dset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54FAA430-940D-7F4A-A641-735244B968F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324100" y="1988344"/>
            <a:ext cx="7543800" cy="4025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45784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EAC05B0-55C2-57A9-0793-AB273EB34B8A}"/>
              </a:ext>
            </a:extLst>
          </p:cNvPr>
          <p:cNvSpPr txBox="1"/>
          <p:nvPr/>
        </p:nvSpPr>
        <p:spPr>
          <a:xfrm>
            <a:off x="1001486" y="1589314"/>
            <a:ext cx="30153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 of woman wearing VR headse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62A39-25D6-E02B-D1C8-17017C6828BF}"/>
              </a:ext>
            </a:extLst>
          </p:cNvPr>
          <p:cNvSpPr txBox="1"/>
          <p:nvPr/>
        </p:nvSpPr>
        <p:spPr>
          <a:xfrm>
            <a:off x="4365173" y="4074663"/>
            <a:ext cx="30153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 of woman wearing VR headset and hand controllers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2639E10-6AD6-518C-AC20-3D925DA5972B}"/>
              </a:ext>
            </a:extLst>
          </p:cNvPr>
          <p:cNvSpPr txBox="1"/>
          <p:nvPr/>
        </p:nvSpPr>
        <p:spPr>
          <a:xfrm>
            <a:off x="8196944" y="1418548"/>
            <a:ext cx="30153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 of man wearing VR headset and hand controllers </a:t>
            </a:r>
          </a:p>
        </p:txBody>
      </p:sp>
    </p:spTree>
    <p:extLst>
      <p:ext uri="{BB962C8B-B14F-4D97-AF65-F5344CB8AC3E}">
        <p14:creationId xmlns:p14="http://schemas.microsoft.com/office/powerpoint/2010/main" val="3620472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8684B0-0DA1-D348-8A22-707E6396CD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R Environments	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DE39A2C-036E-494A-B7F2-0050F03725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8248" y="1690688"/>
            <a:ext cx="5835570" cy="304588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60F9CF9-633A-31BD-B168-AD2B54E3A427}"/>
              </a:ext>
            </a:extLst>
          </p:cNvPr>
          <p:cNvSpPr txBox="1"/>
          <p:nvPr/>
        </p:nvSpPr>
        <p:spPr>
          <a:xfrm>
            <a:off x="7206342" y="3973285"/>
            <a:ext cx="3918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 of passengers in a train carriage </a:t>
            </a:r>
          </a:p>
        </p:txBody>
      </p:sp>
    </p:spTree>
    <p:extLst>
      <p:ext uri="{BB962C8B-B14F-4D97-AF65-F5344CB8AC3E}">
        <p14:creationId xmlns:p14="http://schemas.microsoft.com/office/powerpoint/2010/main" val="20764112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483B83-ECDB-1247-86DC-D06D4F31D9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Video game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E2180E3-6AE7-9B43-B73D-C6C755039F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1211" y="1420812"/>
            <a:ext cx="5154789" cy="354965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78F1E70-BA45-C64A-96C8-7B352C81F3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47552" y="2784475"/>
            <a:ext cx="4506248" cy="370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46853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</TotalTime>
  <Words>39</Words>
  <Application>Microsoft Macintosh PowerPoint</Application>
  <PresentationFormat>Widescreen</PresentationFormat>
  <Paragraphs>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Virtual Reality</vt:lpstr>
      <vt:lpstr>Headset</vt:lpstr>
      <vt:lpstr>PowerPoint Presentation</vt:lpstr>
      <vt:lpstr>VR Environments </vt:lpstr>
      <vt:lpstr>Video gam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irtual Reality</dc:title>
  <dc:creator>Helen Bould</dc:creator>
  <cp:lastModifiedBy>Helen Bould</cp:lastModifiedBy>
  <cp:revision>7</cp:revision>
  <dcterms:created xsi:type="dcterms:W3CDTF">2020-11-02T09:27:59Z</dcterms:created>
  <dcterms:modified xsi:type="dcterms:W3CDTF">2024-05-14T11:38:46Z</dcterms:modified>
</cp:coreProperties>
</file>